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91" d="100"/>
          <a:sy n="91" d="100"/>
        </p:scale>
        <p:origin x="1212" y="5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4EFCE1-9F55-4334-9FAB-872ED94D5772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4A88C8-1A0A-4ED1-A77B-D178B8690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2830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822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166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42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084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690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695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890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822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60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763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336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321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917700" y="1731785"/>
            <a:ext cx="4846320" cy="2743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ounded Rectangle 2"/>
          <p:cNvSpPr/>
          <p:nvPr/>
        </p:nvSpPr>
        <p:spPr>
          <a:xfrm>
            <a:off x="3579378" y="1526348"/>
            <a:ext cx="27432" cy="442570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85157" y="1255387"/>
            <a:ext cx="6158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AO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641052" y="1766289"/>
            <a:ext cx="6078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90 min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961691" y="2026718"/>
            <a:ext cx="8335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erfusion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40638" y="1086110"/>
            <a:ext cx="105990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M095/</a:t>
            </a:r>
          </a:p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ehicle (p.o.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198712" y="1255387"/>
            <a:ext cx="7806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TC staining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003939" y="2026718"/>
            <a:ext cx="1188147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stology/</a:t>
            </a:r>
          </a:p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NA &amp; protein </a:t>
            </a:r>
          </a:p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xtraction</a:t>
            </a:r>
          </a:p>
        </p:txBody>
      </p:sp>
      <p:sp>
        <p:nvSpPr>
          <p:cNvPr id="10" name="Rounded Rectangle 9"/>
          <p:cNvSpPr/>
          <p:nvPr/>
        </p:nvSpPr>
        <p:spPr>
          <a:xfrm>
            <a:off x="5560578" y="1526348"/>
            <a:ext cx="27432" cy="442570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922575" y="4561660"/>
            <a:ext cx="6158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AO</a:t>
            </a:r>
          </a:p>
        </p:txBody>
      </p:sp>
      <p:sp>
        <p:nvSpPr>
          <p:cNvPr id="12" name="Rounded Rectangle 11"/>
          <p:cNvSpPr/>
          <p:nvPr/>
        </p:nvSpPr>
        <p:spPr>
          <a:xfrm>
            <a:off x="3755166" y="4821822"/>
            <a:ext cx="27432" cy="442570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ounded Rectangle 12"/>
          <p:cNvSpPr/>
          <p:nvPr/>
        </p:nvSpPr>
        <p:spPr>
          <a:xfrm>
            <a:off x="5203080" y="4833070"/>
            <a:ext cx="27432" cy="442570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426584" y="5290789"/>
            <a:ext cx="71205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LPA</a:t>
            </a:r>
            <a:r>
              <a:rPr lang="en-US" sz="11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.c.v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)</a:t>
            </a:r>
          </a:p>
        </p:txBody>
      </p:sp>
      <p:sp>
        <p:nvSpPr>
          <p:cNvPr id="15" name="Rounded Rectangle 14"/>
          <p:cNvSpPr/>
          <p:nvPr/>
        </p:nvSpPr>
        <p:spPr>
          <a:xfrm>
            <a:off x="7755879" y="1526348"/>
            <a:ext cx="27432" cy="442570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388406" y="1255387"/>
            <a:ext cx="7806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TC staining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161452" y="2026718"/>
            <a:ext cx="124264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stology/</a:t>
            </a:r>
          </a:p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NA extraction</a:t>
            </a:r>
          </a:p>
        </p:txBody>
      </p:sp>
      <p:sp>
        <p:nvSpPr>
          <p:cNvPr id="18" name="Rectangle 17"/>
          <p:cNvSpPr/>
          <p:nvPr/>
        </p:nvSpPr>
        <p:spPr>
          <a:xfrm>
            <a:off x="2964336" y="5030115"/>
            <a:ext cx="6400800" cy="2743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Flowchart: Punched Tape 18"/>
          <p:cNvSpPr/>
          <p:nvPr/>
        </p:nvSpPr>
        <p:spPr>
          <a:xfrm rot="5400000">
            <a:off x="6324328" y="1655656"/>
            <a:ext cx="251460" cy="192598"/>
          </a:xfrm>
          <a:prstGeom prst="flowChartPunchedTape">
            <a:avLst/>
          </a:prstGeom>
          <a:noFill/>
          <a:ln w="571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Flowchart: Punched Tape 19"/>
          <p:cNvSpPr/>
          <p:nvPr/>
        </p:nvSpPr>
        <p:spPr>
          <a:xfrm rot="5400000">
            <a:off x="4021698" y="4941591"/>
            <a:ext cx="251460" cy="192598"/>
          </a:xfrm>
          <a:prstGeom prst="flowChartPunchedTape">
            <a:avLst/>
          </a:prstGeom>
          <a:noFill/>
          <a:ln w="571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Flowchart: Punched Tape 20"/>
          <p:cNvSpPr/>
          <p:nvPr/>
        </p:nvSpPr>
        <p:spPr>
          <a:xfrm rot="5400000">
            <a:off x="4344570" y="4928591"/>
            <a:ext cx="251460" cy="192598"/>
          </a:xfrm>
          <a:prstGeom prst="flowChartPunchedTape">
            <a:avLst/>
          </a:prstGeom>
          <a:noFill/>
          <a:ln w="571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Flowchart: Punched Tape 21"/>
          <p:cNvSpPr/>
          <p:nvPr/>
        </p:nvSpPr>
        <p:spPr>
          <a:xfrm rot="5400000">
            <a:off x="4496970" y="4936970"/>
            <a:ext cx="251460" cy="192598"/>
          </a:xfrm>
          <a:prstGeom prst="flowChartPunchedTape">
            <a:avLst/>
          </a:prstGeom>
          <a:noFill/>
          <a:ln w="571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4066054" y="4772227"/>
            <a:ext cx="6703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1 Week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503245" y="825777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5" name="Flowchart: Punched Tape 24"/>
          <p:cNvSpPr/>
          <p:nvPr/>
        </p:nvSpPr>
        <p:spPr>
          <a:xfrm rot="5400000">
            <a:off x="4619430" y="1655656"/>
            <a:ext cx="251460" cy="192598"/>
          </a:xfrm>
          <a:prstGeom prst="flowChartPunchedTape">
            <a:avLst/>
          </a:prstGeom>
          <a:noFill/>
          <a:ln w="571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Flowchart: Punched Tape 25"/>
          <p:cNvSpPr/>
          <p:nvPr/>
        </p:nvSpPr>
        <p:spPr>
          <a:xfrm rot="5400000">
            <a:off x="6612167" y="1646280"/>
            <a:ext cx="251460" cy="192598"/>
          </a:xfrm>
          <a:prstGeom prst="flowChartPunchedTape">
            <a:avLst/>
          </a:prstGeom>
          <a:noFill/>
          <a:ln w="571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/>
          <p:cNvSpPr txBox="1"/>
          <p:nvPr/>
        </p:nvSpPr>
        <p:spPr>
          <a:xfrm>
            <a:off x="6252160" y="1787239"/>
            <a:ext cx="599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2 days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658044" y="1766289"/>
            <a:ext cx="5293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1 day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ounded Rectangle 28"/>
          <p:cNvSpPr/>
          <p:nvPr/>
        </p:nvSpPr>
        <p:spPr>
          <a:xfrm>
            <a:off x="4332486" y="1526348"/>
            <a:ext cx="27432" cy="442570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516069" y="4451872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5241997" y="5066572"/>
            <a:ext cx="6078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90 min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562636" y="5290789"/>
            <a:ext cx="8335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erfusion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99657" y="4561660"/>
            <a:ext cx="7806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TC staining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521031" y="5290789"/>
            <a:ext cx="13090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stology</a:t>
            </a:r>
          </a:p>
        </p:txBody>
      </p:sp>
      <p:sp>
        <p:nvSpPr>
          <p:cNvPr id="35" name="Rounded Rectangle 34"/>
          <p:cNvSpPr/>
          <p:nvPr/>
        </p:nvSpPr>
        <p:spPr>
          <a:xfrm>
            <a:off x="7161523" y="4838465"/>
            <a:ext cx="27432" cy="442570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ounded Rectangle 35"/>
          <p:cNvSpPr/>
          <p:nvPr/>
        </p:nvSpPr>
        <p:spPr>
          <a:xfrm>
            <a:off x="9356824" y="4843456"/>
            <a:ext cx="27432" cy="442570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8969985" y="5290789"/>
            <a:ext cx="8274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stology</a:t>
            </a:r>
          </a:p>
        </p:txBody>
      </p:sp>
      <p:sp>
        <p:nvSpPr>
          <p:cNvPr id="38" name="Flowchart: Punched Tape 37"/>
          <p:cNvSpPr/>
          <p:nvPr/>
        </p:nvSpPr>
        <p:spPr>
          <a:xfrm rot="5400000">
            <a:off x="7925273" y="4919727"/>
            <a:ext cx="251460" cy="192598"/>
          </a:xfrm>
          <a:prstGeom prst="flowChartPunchedTape">
            <a:avLst/>
          </a:prstGeom>
          <a:noFill/>
          <a:ln w="571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Flowchart: Punched Tape 38"/>
          <p:cNvSpPr/>
          <p:nvPr/>
        </p:nvSpPr>
        <p:spPr>
          <a:xfrm rot="5400000">
            <a:off x="6220375" y="4919727"/>
            <a:ext cx="251460" cy="192598"/>
          </a:xfrm>
          <a:prstGeom prst="flowChartPunchedTape">
            <a:avLst/>
          </a:prstGeom>
          <a:noFill/>
          <a:ln w="571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Flowchart: Punched Tape 39"/>
          <p:cNvSpPr/>
          <p:nvPr/>
        </p:nvSpPr>
        <p:spPr>
          <a:xfrm rot="5400000">
            <a:off x="8213112" y="4910351"/>
            <a:ext cx="251460" cy="192598"/>
          </a:xfrm>
          <a:prstGeom prst="flowChartPunchedTape">
            <a:avLst/>
          </a:prstGeom>
          <a:noFill/>
          <a:ln w="571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/>
          <p:cNvSpPr txBox="1"/>
          <p:nvPr/>
        </p:nvSpPr>
        <p:spPr>
          <a:xfrm>
            <a:off x="7853105" y="5066572"/>
            <a:ext cx="599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2 days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302121" y="5066572"/>
            <a:ext cx="5293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1 day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ounded Rectangle 42"/>
          <p:cNvSpPr/>
          <p:nvPr/>
        </p:nvSpPr>
        <p:spPr>
          <a:xfrm>
            <a:off x="5933431" y="4841430"/>
            <a:ext cx="27432" cy="442570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2916677" y="3504911"/>
            <a:ext cx="3337560" cy="2743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ounded Rectangle 45"/>
          <p:cNvSpPr/>
          <p:nvPr/>
        </p:nvSpPr>
        <p:spPr>
          <a:xfrm>
            <a:off x="4275245" y="3291884"/>
            <a:ext cx="27432" cy="442570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3981024" y="3020923"/>
            <a:ext cx="6158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AO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4336919" y="3531825"/>
            <a:ext cx="6078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90 min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657558" y="3792254"/>
            <a:ext cx="8335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erfusion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5894579" y="3020923"/>
            <a:ext cx="7806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TC staining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ounded Rectangle 52"/>
          <p:cNvSpPr/>
          <p:nvPr/>
        </p:nvSpPr>
        <p:spPr>
          <a:xfrm>
            <a:off x="6256445" y="3291884"/>
            <a:ext cx="27432" cy="442570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Flowchart: Punched Tape 57"/>
          <p:cNvSpPr/>
          <p:nvPr/>
        </p:nvSpPr>
        <p:spPr>
          <a:xfrm rot="5400000">
            <a:off x="5315297" y="3421192"/>
            <a:ext cx="251460" cy="192598"/>
          </a:xfrm>
          <a:prstGeom prst="flowChartPunchedTape">
            <a:avLst/>
          </a:prstGeom>
          <a:noFill/>
          <a:ln w="571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TextBox 60"/>
          <p:cNvSpPr txBox="1"/>
          <p:nvPr/>
        </p:nvSpPr>
        <p:spPr>
          <a:xfrm>
            <a:off x="5310781" y="3531825"/>
            <a:ext cx="5293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1 day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ounded Rectangle 61"/>
          <p:cNvSpPr/>
          <p:nvPr/>
        </p:nvSpPr>
        <p:spPr>
          <a:xfrm>
            <a:off x="5028353" y="3291884"/>
            <a:ext cx="27432" cy="442570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ounded Rectangle 55"/>
          <p:cNvSpPr/>
          <p:nvPr/>
        </p:nvSpPr>
        <p:spPr>
          <a:xfrm>
            <a:off x="3731778" y="3300508"/>
            <a:ext cx="27432" cy="442570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216892" y="3757840"/>
            <a:ext cx="105990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M095/</a:t>
            </a:r>
          </a:p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ehicle (p.o.)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3817252" y="3531825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1 h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2492025" y="272778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20657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5</TotalTime>
  <Words>65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사용자</dc:creator>
  <cp:lastModifiedBy>Windows 사용자</cp:lastModifiedBy>
  <cp:revision>86</cp:revision>
  <dcterms:created xsi:type="dcterms:W3CDTF">2019-06-25T05:43:47Z</dcterms:created>
  <dcterms:modified xsi:type="dcterms:W3CDTF">2019-06-29T23:53:45Z</dcterms:modified>
</cp:coreProperties>
</file>